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4" d="100"/>
          <a:sy n="74" d="100"/>
        </p:scale>
        <p:origin x="5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2408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660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6074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32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8391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0835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398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6058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1472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2023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23373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BF9B62-3FA3-4072-839A-C04CF972C8B6}" type="datetimeFigureOut">
              <a:rPr lang="en-US" smtClean="0"/>
              <a:t>7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C4620E-D386-46F6-ADC7-2EAF8E98885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692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xmlns="" id="{B2074BB5-104E-CA4E-BE57-3EE31B5AEA4E}"/>
              </a:ext>
            </a:extLst>
          </p:cNvPr>
          <p:cNvSpPr/>
          <p:nvPr/>
        </p:nvSpPr>
        <p:spPr>
          <a:xfrm>
            <a:off x="239062" y="239836"/>
            <a:ext cx="174919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le 1</a:t>
            </a:r>
            <a:endParaRPr lang="fr-FR" dirty="0"/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xmlns="" id="{771C2203-5CA6-0F4D-82CB-EFF2721AC6DE}"/>
              </a:ext>
            </a:extLst>
          </p:cNvPr>
          <p:cNvSpPr txBox="1"/>
          <p:nvPr/>
        </p:nvSpPr>
        <p:spPr>
          <a:xfrm>
            <a:off x="345581" y="5504712"/>
            <a:ext cx="11530189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dirty="0"/>
              <a:t> </a:t>
            </a:r>
            <a:endParaRPr lang="fr-FR" sz="1400" b="1" dirty="0"/>
          </a:p>
          <a:p>
            <a:pPr algn="just"/>
            <a:r>
              <a:rPr lang="en-US" sz="1400" b="1" dirty="0"/>
              <a:t>Additional file 1. Hemodynamic and tissue perfusion parameters at different timepoints in patients without (A) or with PIHI (B). </a:t>
            </a:r>
            <a:r>
              <a:rPr lang="en-US" sz="1400" dirty="0"/>
              <a:t>Data are expressed as medians [interquartile range] for continuous variables, and No. (%) of patients for categorical variables. ND, not determined. </a:t>
            </a:r>
            <a:r>
              <a:rPr lang="en-US" sz="1400" baseline="30000" dirty="0" err="1"/>
              <a:t>a</a:t>
            </a:r>
            <a:r>
              <a:rPr lang="en-US" sz="1400" dirty="0" err="1"/>
              <a:t>Wilcoxon</a:t>
            </a:r>
            <a:r>
              <a:rPr lang="en-US" sz="1400" dirty="0"/>
              <a:t> matched paired test; </a:t>
            </a:r>
            <a:r>
              <a:rPr lang="en-US" sz="1400" baseline="30000" dirty="0" err="1"/>
              <a:t>b</a:t>
            </a:r>
            <a:r>
              <a:rPr lang="en-US" sz="1400" dirty="0" err="1"/>
              <a:t>Comparison</a:t>
            </a:r>
            <a:r>
              <a:rPr lang="en-US" sz="1400" dirty="0"/>
              <a:t> of data observed before versus 5 minutes after TI; </a:t>
            </a:r>
            <a:r>
              <a:rPr lang="en-US" sz="1400" baseline="30000" dirty="0" err="1"/>
              <a:t>c</a:t>
            </a:r>
            <a:r>
              <a:rPr lang="en-US" sz="1400" dirty="0" err="1"/>
              <a:t>Comparison</a:t>
            </a:r>
            <a:r>
              <a:rPr lang="en-US" sz="1400" dirty="0"/>
              <a:t> of data observed before versus 2 hours after TI; </a:t>
            </a:r>
            <a:r>
              <a:rPr lang="en-US" sz="1400" baseline="30000" dirty="0" err="1"/>
              <a:t>d</a:t>
            </a:r>
            <a:r>
              <a:rPr lang="en-US" sz="1400" dirty="0" err="1"/>
              <a:t>Comparison</a:t>
            </a:r>
            <a:r>
              <a:rPr lang="en-US" sz="1400" dirty="0"/>
              <a:t> of data observed 5 minutes after TI versus 2 hours after TI;CRT, capillary refill time, MAP, mean arterial pressure.</a:t>
            </a:r>
            <a:endParaRPr lang="fr-FR" sz="1400" dirty="0"/>
          </a:p>
        </p:txBody>
      </p:sp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xmlns="" id="{0CDB10A5-22B3-BA4B-A79E-312A599602F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352016" y="1104155"/>
          <a:ext cx="5864408" cy="4351339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62777">
                  <a:extLst>
                    <a:ext uri="{9D8B030D-6E8A-4147-A177-3AD203B41FA5}">
                      <a16:colId xmlns:a16="http://schemas.microsoft.com/office/drawing/2014/main" xmlns="" val="4279493355"/>
                    </a:ext>
                  </a:extLst>
                </a:gridCol>
                <a:gridCol w="1180135">
                  <a:extLst>
                    <a:ext uri="{9D8B030D-6E8A-4147-A177-3AD203B41FA5}">
                      <a16:colId xmlns:a16="http://schemas.microsoft.com/office/drawing/2014/main" xmlns="" val="1239770832"/>
                    </a:ext>
                  </a:extLst>
                </a:gridCol>
                <a:gridCol w="1089767">
                  <a:extLst>
                    <a:ext uri="{9D8B030D-6E8A-4147-A177-3AD203B41FA5}">
                      <a16:colId xmlns:a16="http://schemas.microsoft.com/office/drawing/2014/main" xmlns="" val="813118181"/>
                    </a:ext>
                  </a:extLst>
                </a:gridCol>
                <a:gridCol w="979185">
                  <a:extLst>
                    <a:ext uri="{9D8B030D-6E8A-4147-A177-3AD203B41FA5}">
                      <a16:colId xmlns:a16="http://schemas.microsoft.com/office/drawing/2014/main" xmlns="" val="1136406311"/>
                    </a:ext>
                  </a:extLst>
                </a:gridCol>
                <a:gridCol w="1089767">
                  <a:extLst>
                    <a:ext uri="{9D8B030D-6E8A-4147-A177-3AD203B41FA5}">
                      <a16:colId xmlns:a16="http://schemas.microsoft.com/office/drawing/2014/main" xmlns="" val="2360435995"/>
                    </a:ext>
                  </a:extLst>
                </a:gridCol>
                <a:gridCol w="762777">
                  <a:extLst>
                    <a:ext uri="{9D8B030D-6E8A-4147-A177-3AD203B41FA5}">
                      <a16:colId xmlns:a16="http://schemas.microsoft.com/office/drawing/2014/main" xmlns="" val="2341406329"/>
                    </a:ext>
                  </a:extLst>
                </a:gridCol>
              </a:tblGrid>
              <a:tr h="198572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Parameters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Before TI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5 min after TI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 hours after TI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P </a:t>
                      </a: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value</a:t>
                      </a:r>
                      <a:r>
                        <a:rPr lang="fr-FR" sz="900" baseline="30000" dirty="0" err="1">
                          <a:solidFill>
                            <a:schemeClr val="tx1"/>
                          </a:solidFill>
                          <a:effectLst/>
                        </a:rPr>
                        <a:t>a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69016397"/>
                  </a:ext>
                </a:extLst>
              </a:tr>
              <a:tr h="198572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MAP (mmHg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87 [78–94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96 [73–108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77 [69–85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002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40703887"/>
                  </a:ext>
                </a:extLst>
              </a:tr>
              <a:tr h="198572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53424150"/>
                  </a:ext>
                </a:extLst>
              </a:tr>
              <a:tr h="198572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951462357"/>
                  </a:ext>
                </a:extLst>
              </a:tr>
              <a:tr h="198572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Heart rate (/min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94 [82–108]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00 [86–110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88 [77–101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15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66132333"/>
                  </a:ext>
                </a:extLst>
              </a:tr>
              <a:tr h="198572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005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434744090"/>
                  </a:ext>
                </a:extLst>
              </a:tr>
              <a:tr h="198572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06220963"/>
                  </a:ext>
                </a:extLst>
              </a:tr>
              <a:tr h="175385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Cardiac index (L/min/m²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3.2 [2.3–4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.9 [2.2–3.7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03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99991343"/>
                  </a:ext>
                </a:extLst>
              </a:tr>
              <a:tr h="285373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Toe-to room temperature gradient (°C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4.4 [1.3–7.7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3.6 [0.5–9.3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97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34931364"/>
                  </a:ext>
                </a:extLst>
              </a:tr>
              <a:tr h="175385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Arterial lactate levels (mmol/L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3 [0.9–1.8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3 [0.9–1.9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30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304431929"/>
                  </a:ext>
                </a:extLst>
              </a:tr>
              <a:tr h="198572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knee CRT (s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2.0 [1.3-3.0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.0 [1.5–3.1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.0 [1.4–2.7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56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73098011"/>
                  </a:ext>
                </a:extLst>
              </a:tr>
              <a:tr h="198572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58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69508952"/>
                  </a:ext>
                </a:extLst>
              </a:tr>
              <a:tr h="198572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86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95826902"/>
                  </a:ext>
                </a:extLst>
              </a:tr>
              <a:tr h="198572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Index CRT (s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5 [1.0–2.1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6 [1.1–2.4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5 [1.0–2.1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40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227375864"/>
                  </a:ext>
                </a:extLst>
              </a:tr>
              <a:tr h="198572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63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3559389"/>
                  </a:ext>
                </a:extLst>
              </a:tr>
              <a:tr h="198572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39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56470288"/>
                  </a:ext>
                </a:extLst>
              </a:tr>
              <a:tr h="175385">
                <a:tc grid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Mottling score (No. [%] of evaluable patients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545056356"/>
                  </a:ext>
                </a:extLst>
              </a:tr>
              <a:tr h="175385"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-1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56 (86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57 (87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61 (94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6189262"/>
                  </a:ext>
                </a:extLst>
              </a:tr>
              <a:tr h="175385"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-3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7 (11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8 (13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4 (6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13761507"/>
                  </a:ext>
                </a:extLst>
              </a:tr>
              <a:tr h="175385"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4-5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2 (3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 (0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 (0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778273732"/>
                  </a:ext>
                </a:extLst>
              </a:tr>
              <a:tr h="144470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Norepinephrine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 dose (µg/kg/min) 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0 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0-0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0 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0-0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0 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0-0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40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532748300"/>
                  </a:ext>
                </a:extLst>
              </a:tr>
              <a:tr h="143875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0.38</a:t>
                      </a:r>
                      <a:r>
                        <a:rPr lang="fr-FR" sz="900" baseline="30000" dirty="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048993880"/>
                  </a:ext>
                </a:extLst>
              </a:tr>
              <a:tr h="143875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0.42</a:t>
                      </a:r>
                      <a:r>
                        <a:rPr lang="fr-FR" sz="900" baseline="30000" dirty="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209" marR="64209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55727099"/>
                  </a:ext>
                </a:extLst>
              </a:tr>
            </a:tbl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xmlns="" id="{A75AFBD0-9934-A345-AC47-1A55BCAB3D4B}"/>
              </a:ext>
            </a:extLst>
          </p:cNvPr>
          <p:cNvSpPr txBox="1"/>
          <p:nvPr/>
        </p:nvSpPr>
        <p:spPr>
          <a:xfrm>
            <a:off x="193158" y="67199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xmlns="" id="{4022C859-8C25-7540-B625-7F06F935B0CB}"/>
              </a:ext>
            </a:extLst>
          </p:cNvPr>
          <p:cNvSpPr txBox="1"/>
          <p:nvPr/>
        </p:nvSpPr>
        <p:spPr>
          <a:xfrm>
            <a:off x="6259830" y="616043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  <p:graphicFrame>
        <p:nvGraphicFramePr>
          <p:cNvPr id="7" name="Tableau 6">
            <a:extLst>
              <a:ext uri="{FF2B5EF4-FFF2-40B4-BE49-F238E27FC236}">
                <a16:creationId xmlns:a16="http://schemas.microsoft.com/office/drawing/2014/main" xmlns="" id="{218CEF78-0126-2C4B-B672-557A6A0B1C87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414680" y="1113049"/>
          <a:ext cx="5695424" cy="4351335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46538">
                  <a:extLst>
                    <a:ext uri="{9D8B030D-6E8A-4147-A177-3AD203B41FA5}">
                      <a16:colId xmlns:a16="http://schemas.microsoft.com/office/drawing/2014/main" xmlns="" val="2061139510"/>
                    </a:ext>
                  </a:extLst>
                </a:gridCol>
                <a:gridCol w="1167993">
                  <a:extLst>
                    <a:ext uri="{9D8B030D-6E8A-4147-A177-3AD203B41FA5}">
                      <a16:colId xmlns:a16="http://schemas.microsoft.com/office/drawing/2014/main" xmlns="" val="3069922327"/>
                    </a:ext>
                  </a:extLst>
                </a:gridCol>
                <a:gridCol w="1078489">
                  <a:extLst>
                    <a:ext uri="{9D8B030D-6E8A-4147-A177-3AD203B41FA5}">
                      <a16:colId xmlns:a16="http://schemas.microsoft.com/office/drawing/2014/main" xmlns="" val="3618270120"/>
                    </a:ext>
                  </a:extLst>
                </a:gridCol>
                <a:gridCol w="1077377">
                  <a:extLst>
                    <a:ext uri="{9D8B030D-6E8A-4147-A177-3AD203B41FA5}">
                      <a16:colId xmlns:a16="http://schemas.microsoft.com/office/drawing/2014/main" xmlns="" val="1446052728"/>
                    </a:ext>
                  </a:extLst>
                </a:gridCol>
                <a:gridCol w="1078489">
                  <a:extLst>
                    <a:ext uri="{9D8B030D-6E8A-4147-A177-3AD203B41FA5}">
                      <a16:colId xmlns:a16="http://schemas.microsoft.com/office/drawing/2014/main" xmlns="" val="3629096273"/>
                    </a:ext>
                  </a:extLst>
                </a:gridCol>
                <a:gridCol w="646538">
                  <a:extLst>
                    <a:ext uri="{9D8B030D-6E8A-4147-A177-3AD203B41FA5}">
                      <a16:colId xmlns:a16="http://schemas.microsoft.com/office/drawing/2014/main" xmlns="" val="2284963377"/>
                    </a:ext>
                  </a:extLst>
                </a:gridCol>
              </a:tblGrid>
              <a:tr h="198524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Parameters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Before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 TI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5 minutes </a:t>
                      </a: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after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 TI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2 </a:t>
                      </a: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hours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 </a:t>
                      </a: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after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 TI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P </a:t>
                      </a: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value</a:t>
                      </a:r>
                      <a:r>
                        <a:rPr lang="fr-FR" sz="900" baseline="30000" dirty="0" err="1">
                          <a:solidFill>
                            <a:schemeClr val="tx1"/>
                          </a:solidFill>
                          <a:effectLst/>
                        </a:rPr>
                        <a:t>a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404568903"/>
                  </a:ext>
                </a:extLst>
              </a:tr>
              <a:tr h="198524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MAP (mmHg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81 [71–93</a:t>
                      </a: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71 [64–87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69 [64–76]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08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877949889"/>
                  </a:ext>
                </a:extLst>
              </a:tr>
              <a:tr h="198524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73403610"/>
                  </a:ext>
                </a:extLst>
              </a:tr>
              <a:tr h="198524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15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511762086"/>
                  </a:ext>
                </a:extLst>
              </a:tr>
              <a:tr h="198524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Heart</a:t>
                      </a: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 rate (/min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12 [95–130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16 [94–133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18 [89–128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37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36455131"/>
                  </a:ext>
                </a:extLst>
              </a:tr>
              <a:tr h="198524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96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99815213"/>
                  </a:ext>
                </a:extLst>
              </a:tr>
              <a:tr h="198524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45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316762459"/>
                  </a:ext>
                </a:extLst>
              </a:tr>
              <a:tr h="175133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Cardiac index (L/min/m²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.8 [2.1-3.7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.8 [2.0–3.2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08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681732347"/>
                  </a:ext>
                </a:extLst>
              </a:tr>
              <a:tr h="287890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Toe-to room temperature gradient (°C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2.6 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0.2-7.5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.1 [-0.3–7.5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30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260565283"/>
                  </a:ext>
                </a:extLst>
              </a:tr>
              <a:tr h="175133">
                <a:tc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Arterial lactate level (mmol/L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2.3 [1.1-3.5]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N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8 [1.1–3.2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51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26211811"/>
                  </a:ext>
                </a:extLst>
              </a:tr>
              <a:tr h="198524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knee CRT (s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2.9 [2-5.3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3.1 [1.9-4.9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3.2 [1.8–4.9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81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63938357"/>
                  </a:ext>
                </a:extLst>
              </a:tr>
              <a:tr h="198524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98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658416716"/>
                  </a:ext>
                </a:extLst>
              </a:tr>
              <a:tr h="198524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69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40259436"/>
                  </a:ext>
                </a:extLst>
              </a:tr>
              <a:tr h="198524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Index CRT (s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7 [1.1–2.9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7 [1.2–2.9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.6 [1.2–3.1]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39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57491421"/>
                  </a:ext>
                </a:extLst>
              </a:tr>
              <a:tr h="198524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92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391942764"/>
                  </a:ext>
                </a:extLst>
              </a:tr>
              <a:tr h="198524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70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849788386"/>
                  </a:ext>
                </a:extLst>
              </a:tr>
              <a:tr h="175133">
                <a:tc grid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</a:rPr>
                        <a:t>Mottling score (No. [%] of evaluable patients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73895295"/>
                  </a:ext>
                </a:extLst>
              </a:tr>
              <a:tr h="175133"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-1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24 (55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9 (66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9 (66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179643374"/>
                  </a:ext>
                </a:extLst>
              </a:tr>
              <a:tr h="175133"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2-3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11 (25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10 (23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9 (21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797579540"/>
                  </a:ext>
                </a:extLst>
              </a:tr>
              <a:tr h="175133">
                <a:tc>
                  <a:txBody>
                    <a:bodyPr/>
                    <a:lstStyle/>
                    <a:p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4-5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>
                          <a:solidFill>
                            <a:schemeClr val="tx1"/>
                          </a:solidFill>
                          <a:effectLst/>
                        </a:rPr>
                        <a:t>9 (20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5 (11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6 (13)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NS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102739782"/>
                  </a:ext>
                </a:extLst>
              </a:tr>
              <a:tr h="143945">
                <a:tc rowSpan="3" gridSpan="2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 err="1">
                          <a:solidFill>
                            <a:schemeClr val="tx1"/>
                          </a:solidFill>
                          <a:effectLst/>
                        </a:rPr>
                        <a:t>Norepinephrine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 dose (µg/kg/min) 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0 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0 – 0.2</a:t>
                      </a: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</a:endParaRPr>
                    </a:p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100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0 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0- 0.3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3"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0.25 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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0-0.61</a:t>
                      </a: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  <a:sym typeface="Symbol" pitchFamily="2" charset="2"/>
                        </a:rPr>
                        <a:t>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45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b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577918196"/>
                  </a:ext>
                </a:extLst>
              </a:tr>
              <a:tr h="143945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>
                          <a:solidFill>
                            <a:schemeClr val="tx1"/>
                          </a:solidFill>
                          <a:effectLst/>
                        </a:rPr>
                        <a:t>0.04</a:t>
                      </a:r>
                      <a:r>
                        <a:rPr lang="fr-FR" sz="900" baseline="30000">
                          <a:solidFill>
                            <a:schemeClr val="tx1"/>
                          </a:solidFill>
                          <a:effectLst/>
                        </a:rPr>
                        <a:t>C</a:t>
                      </a:r>
                      <a:endParaRPr lang="fr-FR" sz="110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2733244086"/>
                  </a:ext>
                </a:extLst>
              </a:tr>
              <a:tr h="143945">
                <a:tc gridSpan="2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fr-FR" sz="900" dirty="0">
                          <a:solidFill>
                            <a:schemeClr val="tx1"/>
                          </a:solidFill>
                          <a:effectLst/>
                        </a:rPr>
                        <a:t>&lt;0.001</a:t>
                      </a:r>
                      <a:r>
                        <a:rPr lang="fr-FR" sz="900" baseline="30000" dirty="0">
                          <a:solidFill>
                            <a:schemeClr val="tx1"/>
                          </a:solidFill>
                          <a:effectLst/>
                        </a:rPr>
                        <a:t>d</a:t>
                      </a:r>
                      <a:endParaRPr lang="fr-FR" sz="11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775" marR="64775" marT="0" marB="0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8366534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775958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3</Words>
  <Application>Microsoft Office PowerPoint</Application>
  <PresentationFormat>Widescreen</PresentationFormat>
  <Paragraphs>14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nya M.</dc:creator>
  <cp:lastModifiedBy>Saranya M.</cp:lastModifiedBy>
  <cp:revision>1</cp:revision>
  <dcterms:created xsi:type="dcterms:W3CDTF">2022-07-04T08:56:21Z</dcterms:created>
  <dcterms:modified xsi:type="dcterms:W3CDTF">2022-07-04T08:56:26Z</dcterms:modified>
</cp:coreProperties>
</file>